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 snapToGrid="0">
      <p:cViewPr varScale="1">
        <p:scale>
          <a:sx n="74" d="100"/>
          <a:sy n="74" d="100"/>
        </p:scale>
        <p:origin x="7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D5566-C17A-48F0-8A0B-61A8C13680BD}" type="datetimeFigureOut">
              <a:rPr lang="zh-CN" altLang="en-US" smtClean="0"/>
              <a:t>2022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0DFD5-F800-4C8C-A179-694C6EAF27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9717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D5566-C17A-48F0-8A0B-61A8C13680BD}" type="datetimeFigureOut">
              <a:rPr lang="zh-CN" altLang="en-US" smtClean="0"/>
              <a:t>2022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0DFD5-F800-4C8C-A179-694C6EAF27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00168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D5566-C17A-48F0-8A0B-61A8C13680BD}" type="datetimeFigureOut">
              <a:rPr lang="zh-CN" altLang="en-US" smtClean="0"/>
              <a:t>2022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0DFD5-F800-4C8C-A179-694C6EAF27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77510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D5566-C17A-48F0-8A0B-61A8C13680BD}" type="datetimeFigureOut">
              <a:rPr lang="zh-CN" altLang="en-US" smtClean="0"/>
              <a:t>2022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0DFD5-F800-4C8C-A179-694C6EAF27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60727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D5566-C17A-48F0-8A0B-61A8C13680BD}" type="datetimeFigureOut">
              <a:rPr lang="zh-CN" altLang="en-US" smtClean="0"/>
              <a:t>2022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0DFD5-F800-4C8C-A179-694C6EAF27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64210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D5566-C17A-48F0-8A0B-61A8C13680BD}" type="datetimeFigureOut">
              <a:rPr lang="zh-CN" altLang="en-US" smtClean="0"/>
              <a:t>2022/8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0DFD5-F800-4C8C-A179-694C6EAF27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56005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D5566-C17A-48F0-8A0B-61A8C13680BD}" type="datetimeFigureOut">
              <a:rPr lang="zh-CN" altLang="en-US" smtClean="0"/>
              <a:t>2022/8/3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0DFD5-F800-4C8C-A179-694C6EAF27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14996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D5566-C17A-48F0-8A0B-61A8C13680BD}" type="datetimeFigureOut">
              <a:rPr lang="zh-CN" altLang="en-US" smtClean="0"/>
              <a:t>2022/8/3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0DFD5-F800-4C8C-A179-694C6EAF27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11520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D5566-C17A-48F0-8A0B-61A8C13680BD}" type="datetimeFigureOut">
              <a:rPr lang="zh-CN" altLang="en-US" smtClean="0"/>
              <a:t>2022/8/3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0DFD5-F800-4C8C-A179-694C6EAF27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39222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D5566-C17A-48F0-8A0B-61A8C13680BD}" type="datetimeFigureOut">
              <a:rPr lang="zh-CN" altLang="en-US" smtClean="0"/>
              <a:t>2022/8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0DFD5-F800-4C8C-A179-694C6EAF27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20138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D5566-C17A-48F0-8A0B-61A8C13680BD}" type="datetimeFigureOut">
              <a:rPr lang="zh-CN" altLang="en-US" smtClean="0"/>
              <a:t>2022/8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0DFD5-F800-4C8C-A179-694C6EAF27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68811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AD5566-C17A-48F0-8A0B-61A8C13680BD}" type="datetimeFigureOut">
              <a:rPr lang="zh-CN" altLang="en-US" smtClean="0"/>
              <a:t>2022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30DFD5-F800-4C8C-A179-694C6EAF27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93696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文本框 18"/>
          <p:cNvSpPr txBox="1"/>
          <p:nvPr/>
        </p:nvSpPr>
        <p:spPr>
          <a:xfrm>
            <a:off x="446170" y="150074"/>
            <a:ext cx="115704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en-US" altLang="zh-CN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imeline of the clinical course in this </a:t>
            </a:r>
            <a:r>
              <a:rPr lang="en-US" altLang="zh-CN" sz="1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tient</a:t>
            </a:r>
            <a:r>
              <a:rPr lang="en-US" altLang="zh-CN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sz="14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2" name="图片 7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8274" y="1559218"/>
            <a:ext cx="10231650" cy="32270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34917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文本框 18"/>
          <p:cNvSpPr txBox="1"/>
          <p:nvPr/>
        </p:nvSpPr>
        <p:spPr>
          <a:xfrm>
            <a:off x="446170" y="150074"/>
            <a:ext cx="115704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ext-generation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ing analysis of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EGFR p.L861Q and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EGFR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G719C mutations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the patient’s biopsy sample.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2184" y="457851"/>
            <a:ext cx="11083489" cy="62184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25381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</Words>
  <Application>Microsoft Office PowerPoint</Application>
  <PresentationFormat>宽屏</PresentationFormat>
  <Paragraphs>2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帐户</dc:creator>
  <cp:lastModifiedBy>Microsoft 帐户</cp:lastModifiedBy>
  <cp:revision>1</cp:revision>
  <dcterms:created xsi:type="dcterms:W3CDTF">2022-08-31T12:37:02Z</dcterms:created>
  <dcterms:modified xsi:type="dcterms:W3CDTF">2022-08-31T12:37:44Z</dcterms:modified>
</cp:coreProperties>
</file>